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10"/>
  </p:notesMasterIdLst>
  <p:sldIdLst>
    <p:sldId id="324" r:id="rId2"/>
    <p:sldId id="325" r:id="rId3"/>
    <p:sldId id="327" r:id="rId4"/>
    <p:sldId id="328" r:id="rId5"/>
    <p:sldId id="329" r:id="rId6"/>
    <p:sldId id="330" r:id="rId7"/>
    <p:sldId id="331" r:id="rId8"/>
    <p:sldId id="332" r:id="rId9"/>
  </p:sldIdLst>
  <p:sldSz cx="6858000" cy="9144000" type="screen4x3"/>
  <p:notesSz cx="7010400" cy="92964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792">
          <p15:clr>
            <a:srgbClr val="A4A3A4"/>
          </p15:clr>
        </p15:guide>
        <p15:guide id="2" pos="3120">
          <p15:clr>
            <a:srgbClr val="A4A3A4"/>
          </p15:clr>
        </p15:guide>
      </p15:sldGuideLst>
    </p:ext>
    <p:ext uri="{2D200454-40CA-4A62-9FC3-DE9A4176ACB9}">
      <p15:notes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0" name="hwsedero" initials="h" lastIdx="2" clrIdx="0"/>
  <p:cmAuthor id="1" name="Soundarya Srirangan" initials="SS" lastIdx="9" clrIdx="1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ECECEC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5940675A-B579-460E-94D1-54222C63F5DA}" styleName="No Style, Table Grid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7450" autoAdjust="0"/>
    <p:restoredTop sz="99856" autoAdjust="0"/>
  </p:normalViewPr>
  <p:slideViewPr>
    <p:cSldViewPr>
      <p:cViewPr varScale="1">
        <p:scale>
          <a:sx n="53" d="100"/>
          <a:sy n="53" d="100"/>
        </p:scale>
        <p:origin x="1968" y="48"/>
      </p:cViewPr>
      <p:guideLst>
        <p:guide orient="horz" pos="3792"/>
        <p:guide pos="312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notesViewPr>
    <p:cSldViewPr>
      <p:cViewPr varScale="1">
        <p:scale>
          <a:sx n="53" d="100"/>
          <a:sy n="53" d="100"/>
        </p:scale>
        <p:origin x="2624" y="28"/>
      </p:cViewPr>
      <p:guideLst/>
    </p:cSldViewPr>
  </p:notes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commentAuthors" Target="commentAuthors.xml"/><Relationship Id="rId5" Type="http://schemas.openxmlformats.org/officeDocument/2006/relationships/slide" Target="slides/slide4.xml"/><Relationship Id="rId15" Type="http://schemas.openxmlformats.org/officeDocument/2006/relationships/tableStyles" Target="tableStyles.xml"/><Relationship Id="rId10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heme" Target="theme/them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1" y="0"/>
            <a:ext cx="3037840" cy="464820"/>
          </a:xfrm>
          <a:prstGeom prst="rect">
            <a:avLst/>
          </a:prstGeom>
        </p:spPr>
        <p:txBody>
          <a:bodyPr vert="horz" lIns="93177" tIns="46589" rIns="93177" bIns="46589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970939" y="0"/>
            <a:ext cx="3037840" cy="464820"/>
          </a:xfrm>
          <a:prstGeom prst="rect">
            <a:avLst/>
          </a:prstGeom>
        </p:spPr>
        <p:txBody>
          <a:bodyPr vert="horz" lIns="93177" tIns="46589" rIns="93177" bIns="46589" rtlCol="0"/>
          <a:lstStyle>
            <a:lvl1pPr algn="r">
              <a:defRPr sz="1200"/>
            </a:lvl1pPr>
          </a:lstStyle>
          <a:p>
            <a:fld id="{F0638EF7-21BA-46D6-B331-2665E60F3993}" type="datetimeFigureOut">
              <a:rPr lang="en-US" smtClean="0"/>
              <a:pPr/>
              <a:t>1/19/2015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197100" y="696913"/>
            <a:ext cx="2616200" cy="348615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3177" tIns="46589" rIns="93177" bIns="46589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701041" y="4415790"/>
            <a:ext cx="5608320" cy="4183380"/>
          </a:xfrm>
          <a:prstGeom prst="rect">
            <a:avLst/>
          </a:prstGeom>
        </p:spPr>
        <p:txBody>
          <a:bodyPr vert="horz" lIns="93177" tIns="46589" rIns="93177" bIns="46589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1" y="8829967"/>
            <a:ext cx="3037840" cy="464820"/>
          </a:xfrm>
          <a:prstGeom prst="rect">
            <a:avLst/>
          </a:prstGeom>
        </p:spPr>
        <p:txBody>
          <a:bodyPr vert="horz" lIns="93177" tIns="46589" rIns="93177" bIns="46589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970939" y="8829967"/>
            <a:ext cx="3037840" cy="464820"/>
          </a:xfrm>
          <a:prstGeom prst="rect">
            <a:avLst/>
          </a:prstGeom>
        </p:spPr>
        <p:txBody>
          <a:bodyPr vert="horz" lIns="93177" tIns="46589" rIns="93177" bIns="46589" rtlCol="0" anchor="b"/>
          <a:lstStyle>
            <a:lvl1pPr algn="r">
              <a:defRPr sz="1200"/>
            </a:lvl1pPr>
          </a:lstStyle>
          <a:p>
            <a:fld id="{8A23745D-2A52-4D76-8184-F020C4DF11F2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0626356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078704-86FC-4871-8292-C5A59EA7DC58}" type="datetimeFigureOut">
              <a:rPr lang="en-US" smtClean="0"/>
              <a:pPr/>
              <a:t>1/19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785DCB-3165-4B21-B215-8E13A81A03C4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078704-86FC-4871-8292-C5A59EA7DC58}" type="datetimeFigureOut">
              <a:rPr lang="en-US" smtClean="0"/>
              <a:pPr/>
              <a:t>1/19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785DCB-3165-4B21-B215-8E13A81A03C4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078704-86FC-4871-8292-C5A59EA7DC58}" type="datetimeFigureOut">
              <a:rPr lang="en-US" smtClean="0"/>
              <a:pPr/>
              <a:t>1/19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785DCB-3165-4B21-B215-8E13A81A03C4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078704-86FC-4871-8292-C5A59EA7DC58}" type="datetimeFigureOut">
              <a:rPr lang="en-US" smtClean="0"/>
              <a:pPr/>
              <a:t>1/19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785DCB-3165-4B21-B215-8E13A81A03C4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078704-86FC-4871-8292-C5A59EA7DC58}" type="datetimeFigureOut">
              <a:rPr lang="en-US" smtClean="0"/>
              <a:pPr/>
              <a:t>1/19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785DCB-3165-4B21-B215-8E13A81A03C4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078704-86FC-4871-8292-C5A59EA7DC58}" type="datetimeFigureOut">
              <a:rPr lang="en-US" smtClean="0"/>
              <a:pPr/>
              <a:t>1/19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785DCB-3165-4B21-B215-8E13A81A03C4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078704-86FC-4871-8292-C5A59EA7DC58}" type="datetimeFigureOut">
              <a:rPr lang="en-US" smtClean="0"/>
              <a:pPr/>
              <a:t>1/19/201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785DCB-3165-4B21-B215-8E13A81A03C4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078704-86FC-4871-8292-C5A59EA7DC58}" type="datetimeFigureOut">
              <a:rPr lang="en-US" smtClean="0"/>
              <a:pPr/>
              <a:t>1/19/201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785DCB-3165-4B21-B215-8E13A81A03C4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078704-86FC-4871-8292-C5A59EA7DC58}" type="datetimeFigureOut">
              <a:rPr lang="en-US" smtClean="0"/>
              <a:pPr/>
              <a:t>1/19/201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785DCB-3165-4B21-B215-8E13A81A03C4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078704-86FC-4871-8292-C5A59EA7DC58}" type="datetimeFigureOut">
              <a:rPr lang="en-US" smtClean="0"/>
              <a:pPr/>
              <a:t>1/19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785DCB-3165-4B21-B215-8E13A81A03C4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078704-86FC-4871-8292-C5A59EA7DC58}" type="datetimeFigureOut">
              <a:rPr lang="en-US" smtClean="0"/>
              <a:pPr/>
              <a:t>1/19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785DCB-3165-4B21-B215-8E13A81A03C4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3078704-86FC-4871-8292-C5A59EA7DC58}" type="datetimeFigureOut">
              <a:rPr lang="en-US" smtClean="0"/>
              <a:pPr/>
              <a:t>1/19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0785DCB-3165-4B21-B215-8E13A81A03C4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png"/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png"/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.png"/><Relationship Id="rId2" Type="http://schemas.openxmlformats.org/officeDocument/2006/relationships/image" Target="../media/image10.png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3.png"/><Relationship Id="rId2" Type="http://schemas.openxmlformats.org/officeDocument/2006/relationships/image" Target="../media/image12.png"/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15.png"/><Relationship Id="rId2" Type="http://schemas.openxmlformats.org/officeDocument/2006/relationships/image" Target="../media/image14.png"/><Relationship Id="rId1" Type="http://schemas.openxmlformats.org/officeDocument/2006/relationships/slideLayout" Target="../slideLayouts/slideLayout7.xml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17.png"/><Relationship Id="rId2" Type="http://schemas.openxmlformats.org/officeDocument/2006/relationships/image" Target="../media/image16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TextBox 13"/>
          <p:cNvSpPr txBox="1"/>
          <p:nvPr/>
        </p:nvSpPr>
        <p:spPr>
          <a:xfrm>
            <a:off x="618371" y="3705999"/>
            <a:ext cx="28725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</a:p>
        </p:txBody>
      </p:sp>
      <p:sp>
        <p:nvSpPr>
          <p:cNvPr id="15" name="TextBox 14"/>
          <p:cNvSpPr txBox="1"/>
          <p:nvPr/>
        </p:nvSpPr>
        <p:spPr>
          <a:xfrm>
            <a:off x="554500" y="457199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16" name="Group 15"/>
          <p:cNvGrpSpPr/>
          <p:nvPr/>
        </p:nvGrpSpPr>
        <p:grpSpPr>
          <a:xfrm>
            <a:off x="762000" y="595699"/>
            <a:ext cx="5538472" cy="3048000"/>
            <a:chOff x="457200" y="4343400"/>
            <a:chExt cx="5538472" cy="3048000"/>
          </a:xfrm>
        </p:grpSpPr>
        <p:pic>
          <p:nvPicPr>
            <p:cNvPr id="17" name="Picture 3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457200" y="4343400"/>
              <a:ext cx="5538472" cy="297180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18" name="Picture 2"/>
            <p:cNvPicPr>
              <a:picLocks noChangeAspect="1" noChangeArrowheads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906922" y="7161447"/>
              <a:ext cx="381000" cy="229953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19" name="Picture 2"/>
            <p:cNvPicPr>
              <a:picLocks noChangeAspect="1" noChangeArrowheads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4114800" y="7161446"/>
              <a:ext cx="381000" cy="229953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</p:grpSp>
      <p:pic>
        <p:nvPicPr>
          <p:cNvPr id="20" name="Picture 4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82836" y="3888864"/>
            <a:ext cx="5010172" cy="260755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10" name="TextBox 9"/>
          <p:cNvSpPr txBox="1"/>
          <p:nvPr/>
        </p:nvSpPr>
        <p:spPr>
          <a:xfrm>
            <a:off x="497208" y="6858000"/>
            <a:ext cx="5803264" cy="93871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1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</a:t>
            </a:r>
            <a:r>
              <a:rPr lang="en-US" sz="11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1</a:t>
            </a:r>
            <a:r>
              <a:rPr lang="en-US" sz="11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1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ure. </a:t>
            </a:r>
            <a:r>
              <a:rPr lang="en-US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ranscript profile for Carbonic anhydrases (A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, Light Harvesting Complexes </a:t>
            </a:r>
            <a:r>
              <a:rPr lang="en-US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B), Photosystem II (C), Photosystem I (D), ACCase subunits (E), </a:t>
            </a:r>
            <a:r>
              <a:rPr lang="en-US" sz="11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Ketoacyl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r>
              <a:rPr lang="en-US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CP synthase (F), Fatty acid synthase (G), Membrane lipid synthesis (H), Fatty acid desaturation and elongation (I), Lipid and TAG synthesis (J), Major Lipid Droplet Protein (K), Lipases (L), </a:t>
            </a:r>
            <a:r>
              <a:rPr lang="el-GR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β</a:t>
            </a:r>
            <a:r>
              <a:rPr lang="en-US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-Oxidation (M), </a:t>
            </a:r>
            <a:r>
              <a:rPr lang="en-US" sz="11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Glyoxylate</a:t>
            </a:r>
            <a:r>
              <a:rPr lang="en-US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cycle specific enzymes (N) and Starch metabolism (O and P).  X-axis represents hours.</a:t>
            </a:r>
            <a:endParaRPr lang="en-US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27363450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075" name="Picture 3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877597" y="4572001"/>
            <a:ext cx="4989804" cy="309810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3077" name="Picture 5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016177" y="886599"/>
            <a:ext cx="4807974" cy="332340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6" name="TextBox 5"/>
          <p:cNvSpPr txBox="1"/>
          <p:nvPr/>
        </p:nvSpPr>
        <p:spPr>
          <a:xfrm>
            <a:off x="1143000" y="618869"/>
            <a:ext cx="28725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1217785" y="4322332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D</a:t>
            </a:r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" name="TextBox 9"/>
          <p:cNvSpPr txBox="1"/>
          <p:nvPr/>
        </p:nvSpPr>
        <p:spPr>
          <a:xfrm>
            <a:off x="470867" y="7772400"/>
            <a:ext cx="5803264" cy="110799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1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</a:t>
            </a:r>
            <a:r>
              <a:rPr lang="en-US" sz="11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1</a:t>
            </a:r>
            <a:r>
              <a:rPr lang="en-US" sz="11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1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ure. </a:t>
            </a:r>
            <a:r>
              <a:rPr lang="en-US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ranscript profile for Carbonic anhydrases (A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, Light Harvesting Complexes </a:t>
            </a:r>
            <a:r>
              <a:rPr lang="en-US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B), Photosystem II (C), Photosystem I (D), ACCase subunits (E), </a:t>
            </a:r>
            <a:r>
              <a:rPr lang="en-US" sz="11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Ketoacyl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r>
              <a:rPr lang="en-US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CP synthase (F), Fatty acid synthase (G), Membrane lipid synthesis (H), Fatty acid desaturation and elongation (I), Lipid and TAG synthesis (J), Major Lipid Droplet Protein (K), Lipases (L), </a:t>
            </a:r>
            <a:r>
              <a:rPr lang="el-GR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β</a:t>
            </a:r>
            <a:r>
              <a:rPr lang="en-US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-Oxidation (M), </a:t>
            </a:r>
            <a:r>
              <a:rPr lang="en-US" sz="11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Glyoxylate</a:t>
            </a:r>
            <a:r>
              <a:rPr lang="en-US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cycle specific enzymes (N) and Starch metabolism (O and P). 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X-axis represents hours.</a:t>
            </a:r>
          </a:p>
          <a:p>
            <a:pPr algn="just"/>
            <a:endParaRPr lang="en-US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29326261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7" name="Picture 3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869950" y="914400"/>
            <a:ext cx="4768850" cy="303676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28" name="Picture 4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989535" y="4114800"/>
            <a:ext cx="4876800" cy="323621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4" name="TextBox 3"/>
          <p:cNvSpPr txBox="1"/>
          <p:nvPr/>
        </p:nvSpPr>
        <p:spPr>
          <a:xfrm>
            <a:off x="654847" y="4066401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</a:t>
            </a:r>
          </a:p>
        </p:txBody>
      </p:sp>
      <p:sp>
        <p:nvSpPr>
          <p:cNvPr id="5" name="TextBox 4"/>
          <p:cNvSpPr txBox="1"/>
          <p:nvPr/>
        </p:nvSpPr>
        <p:spPr>
          <a:xfrm>
            <a:off x="694261" y="722870"/>
            <a:ext cx="2792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E</a:t>
            </a:r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" name="TextBox 8"/>
          <p:cNvSpPr txBox="1"/>
          <p:nvPr/>
        </p:nvSpPr>
        <p:spPr>
          <a:xfrm>
            <a:off x="622763" y="7514656"/>
            <a:ext cx="5803264" cy="110799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1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</a:t>
            </a:r>
            <a:r>
              <a:rPr lang="en-US" sz="11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1</a:t>
            </a:r>
            <a:r>
              <a:rPr lang="en-US" sz="11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1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ure. </a:t>
            </a:r>
            <a:r>
              <a:rPr lang="en-US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ranscript profile for Carbonic anhydrases (A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, Light Harvesting Complexes </a:t>
            </a:r>
            <a:r>
              <a:rPr lang="en-US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B), Photosystem II (C), Photosystem I (D), ACCase subunits (E), </a:t>
            </a:r>
            <a:r>
              <a:rPr lang="en-US" sz="11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Ketoacyl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r>
              <a:rPr lang="en-US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CP synthase (F), Fatty acid synthase (G), Membrane lipid synthesis (H), Fatty acid desaturation and elongation (I), Lipid and TAG synthesis (J), Major Lipid Droplet Protein (K), Lipases (L), </a:t>
            </a:r>
            <a:r>
              <a:rPr lang="el-GR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β</a:t>
            </a:r>
            <a:r>
              <a:rPr lang="en-US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-Oxidation (M), </a:t>
            </a:r>
            <a:r>
              <a:rPr lang="en-US" sz="11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Glyoxylate</a:t>
            </a:r>
            <a:r>
              <a:rPr lang="en-US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cycle specific enzymes (N) and Starch metabolism (O and P). 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X-axis represents hours.</a:t>
            </a:r>
          </a:p>
          <a:p>
            <a:pPr algn="just"/>
            <a:endParaRPr lang="en-US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61923141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076" name="Picture 4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870611" y="4197521"/>
            <a:ext cx="4735779" cy="351478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27" name="Picture 3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990601" y="762000"/>
            <a:ext cx="4495800" cy="310868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4" name="TextBox 3"/>
          <p:cNvSpPr txBox="1"/>
          <p:nvPr/>
        </p:nvSpPr>
        <p:spPr>
          <a:xfrm>
            <a:off x="945292" y="3920522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</a:t>
            </a:r>
          </a:p>
        </p:txBody>
      </p:sp>
      <p:sp>
        <p:nvSpPr>
          <p:cNvPr id="5" name="TextBox 4"/>
          <p:cNvSpPr txBox="1"/>
          <p:nvPr/>
        </p:nvSpPr>
        <p:spPr>
          <a:xfrm>
            <a:off x="914400" y="457200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G</a:t>
            </a:r>
          </a:p>
        </p:txBody>
      </p:sp>
      <p:sp>
        <p:nvSpPr>
          <p:cNvPr id="9" name="TextBox 8"/>
          <p:cNvSpPr txBox="1"/>
          <p:nvPr/>
        </p:nvSpPr>
        <p:spPr>
          <a:xfrm>
            <a:off x="457200" y="7848600"/>
            <a:ext cx="5803264" cy="110799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1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</a:t>
            </a:r>
            <a:r>
              <a:rPr lang="en-US" sz="11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1</a:t>
            </a:r>
            <a:r>
              <a:rPr lang="en-US" sz="11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1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ure. </a:t>
            </a:r>
            <a:r>
              <a:rPr lang="en-US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ranscript profile for Carbonic anhydrases (A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, Light Harvesting Complexes </a:t>
            </a:r>
            <a:r>
              <a:rPr lang="en-US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B), Photosystem II (C), Photosystem I (D), ACCase subunits (E), </a:t>
            </a:r>
            <a:r>
              <a:rPr lang="en-US" sz="11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Ketoacyl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r>
              <a:rPr lang="en-US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CP synthase (F), Fatty acid synthase (G), Membrane lipid synthesis (H), Fatty acid desaturation and elongation (I), Lipid and TAG synthesis (J), Major Lipid Droplet Protein (K), Lipases (L), </a:t>
            </a:r>
            <a:r>
              <a:rPr lang="el-GR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β</a:t>
            </a:r>
            <a:r>
              <a:rPr lang="en-US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-Oxidation (M), </a:t>
            </a:r>
            <a:r>
              <a:rPr lang="en-US" sz="11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Glyoxylate</a:t>
            </a:r>
            <a:r>
              <a:rPr lang="en-US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cycle specific enzymes (N) and Starch metabolism (O and P). 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X-axis represents hours.</a:t>
            </a:r>
          </a:p>
          <a:p>
            <a:pPr algn="just"/>
            <a:endParaRPr lang="en-US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15244840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7" name="Picture 3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054156" y="304799"/>
            <a:ext cx="4813244" cy="351387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6" name="TextBox 5"/>
          <p:cNvSpPr txBox="1"/>
          <p:nvPr/>
        </p:nvSpPr>
        <p:spPr>
          <a:xfrm>
            <a:off x="896075" y="3810655"/>
            <a:ext cx="24397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J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936175" y="304799"/>
            <a:ext cx="23596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</a:t>
            </a:r>
          </a:p>
        </p:txBody>
      </p:sp>
      <p:pic>
        <p:nvPicPr>
          <p:cNvPr id="2" name="Picture 1"/>
          <p:cNvPicPr>
            <a:picLocks noChangeAspect="1"/>
          </p:cNvPicPr>
          <p:nvPr/>
        </p:nvPicPr>
        <p:blipFill rotWithShape="1">
          <a:blip r:embed="rId3"/>
          <a:srcRect b="10196"/>
          <a:stretch/>
        </p:blipFill>
        <p:spPr>
          <a:xfrm>
            <a:off x="978675" y="3949632"/>
            <a:ext cx="5269725" cy="3594167"/>
          </a:xfrm>
          <a:prstGeom prst="rect">
            <a:avLst/>
          </a:prstGeom>
        </p:spPr>
      </p:pic>
      <p:sp>
        <p:nvSpPr>
          <p:cNvPr id="10" name="TextBox 9"/>
          <p:cNvSpPr txBox="1"/>
          <p:nvPr/>
        </p:nvSpPr>
        <p:spPr>
          <a:xfrm>
            <a:off x="445136" y="7674755"/>
            <a:ext cx="5803264" cy="110799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1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</a:t>
            </a:r>
            <a:r>
              <a:rPr lang="en-US" sz="11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1</a:t>
            </a:r>
            <a:r>
              <a:rPr lang="en-US" sz="11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1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ure. </a:t>
            </a:r>
            <a:r>
              <a:rPr lang="en-US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ranscript profile for Carbonic anhydrases (A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, Light Harvesting Complexes </a:t>
            </a:r>
            <a:r>
              <a:rPr lang="en-US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B), Photosystem II (C), Photosystem I (D), ACCase subunits (E), </a:t>
            </a:r>
            <a:r>
              <a:rPr lang="en-US" sz="11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Ketoacyl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r>
              <a:rPr lang="en-US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CP synthase (F), Fatty acid synthase (G), Membrane lipid synthesis (H), Fatty acid desaturation and elongation (I), Lipid and TAG synthesis (J), Major Lipid Droplet Protein (K), Lipases (L), </a:t>
            </a:r>
            <a:r>
              <a:rPr lang="el-GR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β</a:t>
            </a:r>
            <a:r>
              <a:rPr lang="en-US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-Oxidation (M), </a:t>
            </a:r>
            <a:r>
              <a:rPr lang="en-US" sz="11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Glyoxylate</a:t>
            </a:r>
            <a:r>
              <a:rPr lang="en-US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cycle specific enzymes (N) and Starch metabolism (O and P). 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X-axis represents hours.</a:t>
            </a:r>
          </a:p>
          <a:p>
            <a:pPr algn="just"/>
            <a:endParaRPr lang="en-US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20141780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55" name="Picture 7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914400" y="304800"/>
            <a:ext cx="4401863" cy="294363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5" name="TextBox 4"/>
          <p:cNvSpPr txBox="1"/>
          <p:nvPr/>
        </p:nvSpPr>
        <p:spPr>
          <a:xfrm>
            <a:off x="914400" y="381000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K</a:t>
            </a:r>
          </a:p>
        </p:txBody>
      </p:sp>
      <p:sp>
        <p:nvSpPr>
          <p:cNvPr id="6" name="TextBox 5"/>
          <p:cNvSpPr txBox="1"/>
          <p:nvPr/>
        </p:nvSpPr>
        <p:spPr>
          <a:xfrm>
            <a:off x="930430" y="3248437"/>
            <a:ext cx="2792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L</a:t>
            </a:r>
          </a:p>
        </p:txBody>
      </p:sp>
      <p:pic>
        <p:nvPicPr>
          <p:cNvPr id="2" name="Picture 1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819736" y="3505200"/>
            <a:ext cx="5733464" cy="3865199"/>
          </a:xfrm>
          <a:prstGeom prst="rect">
            <a:avLst/>
          </a:prstGeom>
        </p:spPr>
      </p:pic>
      <p:sp>
        <p:nvSpPr>
          <p:cNvPr id="9" name="TextBox 8"/>
          <p:cNvSpPr txBox="1"/>
          <p:nvPr/>
        </p:nvSpPr>
        <p:spPr>
          <a:xfrm>
            <a:off x="533400" y="7543800"/>
            <a:ext cx="5803264" cy="110799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1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</a:t>
            </a:r>
            <a:r>
              <a:rPr lang="en-US" sz="11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1 </a:t>
            </a:r>
            <a:r>
              <a:rPr lang="en-US" sz="11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ure</a:t>
            </a:r>
            <a:r>
              <a:rPr lang="en-US" sz="11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US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ranscript profile for Carbonic anhydrases (A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, Light Harvesting Complexes </a:t>
            </a:r>
            <a:r>
              <a:rPr lang="en-US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B), Photosystem II (C), Photosystem I (D), ACCase subunits (E), </a:t>
            </a:r>
            <a:r>
              <a:rPr lang="en-US" sz="11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Ketoacyl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r>
              <a:rPr lang="en-US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CP synthase (F), Fatty acid synthase (G), Membrane lipid synthesis (H), Fatty acid desaturation and elongation (I), Lipid and TAG synthesis (J), Major Lipid Droplet Protein (K), Lipases (L), </a:t>
            </a:r>
            <a:r>
              <a:rPr lang="el-GR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β</a:t>
            </a:r>
            <a:r>
              <a:rPr lang="en-US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-Oxidation (M), </a:t>
            </a:r>
            <a:r>
              <a:rPr lang="en-US" sz="11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Glyoxylate</a:t>
            </a:r>
            <a:r>
              <a:rPr lang="en-US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cycle specific enzymes (N) and Starch metabolism (O and P). 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X-axis represents hours.</a:t>
            </a:r>
          </a:p>
          <a:p>
            <a:pPr algn="just"/>
            <a:endParaRPr lang="en-US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28006700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7" name="Picture 3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62000" y="762000"/>
            <a:ext cx="5220330" cy="35814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28" name="Picture 4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66618" y="4724400"/>
            <a:ext cx="5140107" cy="28956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7" name="TextBox 6"/>
          <p:cNvSpPr txBox="1"/>
          <p:nvPr/>
        </p:nvSpPr>
        <p:spPr>
          <a:xfrm>
            <a:off x="655936" y="695325"/>
            <a:ext cx="32092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</a:t>
            </a:r>
            <a:endParaRPr lang="en-US" sz="1200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" name="TextBox 7"/>
          <p:cNvSpPr txBox="1"/>
          <p:nvPr/>
        </p:nvSpPr>
        <p:spPr>
          <a:xfrm>
            <a:off x="738155" y="4431268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N</a:t>
            </a:r>
          </a:p>
        </p:txBody>
      </p:sp>
      <p:sp>
        <p:nvSpPr>
          <p:cNvPr id="11" name="TextBox 10"/>
          <p:cNvSpPr txBox="1"/>
          <p:nvPr/>
        </p:nvSpPr>
        <p:spPr>
          <a:xfrm>
            <a:off x="470533" y="7802344"/>
            <a:ext cx="5803264" cy="110799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1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</a:t>
            </a:r>
            <a:r>
              <a:rPr lang="en-US" sz="11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1</a:t>
            </a:r>
            <a:r>
              <a:rPr lang="en-US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1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ure</a:t>
            </a:r>
            <a:r>
              <a:rPr lang="en-US" sz="11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US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ranscript profile for Carbonic anhydrases (A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, Light Harvesting Complexes </a:t>
            </a:r>
            <a:r>
              <a:rPr lang="en-US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B), Photosystem II (C), Photosystem I (D), ACCase subunits (E), </a:t>
            </a:r>
            <a:r>
              <a:rPr lang="en-US" sz="11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Ketoacyl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r>
              <a:rPr lang="en-US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CP synthase (F), Fatty acid synthase (G), Membrane lipid synthesis (H), Fatty acid desaturation and elongation (I), Lipid and TAG synthesis (J), Major Lipid Droplet Protein (K), Lipases (L), </a:t>
            </a:r>
            <a:r>
              <a:rPr lang="el-GR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β</a:t>
            </a:r>
            <a:r>
              <a:rPr lang="en-US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-Oxidation (M), </a:t>
            </a:r>
            <a:r>
              <a:rPr lang="en-US" sz="11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Glyoxylate</a:t>
            </a:r>
            <a:r>
              <a:rPr lang="en-US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cycle specific enzymes (N) and Starch metabolism (O and P). 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X-axis represents hours.</a:t>
            </a:r>
          </a:p>
          <a:p>
            <a:pPr algn="just"/>
            <a:endParaRPr lang="en-US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22451957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52" name="Picture 4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961768" y="4419600"/>
            <a:ext cx="4296032" cy="287663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2054" name="Picture 6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838201" y="685800"/>
            <a:ext cx="4724399" cy="340143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4" name="TextBox 3"/>
          <p:cNvSpPr txBox="1"/>
          <p:nvPr/>
        </p:nvSpPr>
        <p:spPr>
          <a:xfrm>
            <a:off x="601684" y="685800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O</a:t>
            </a:r>
          </a:p>
        </p:txBody>
      </p:sp>
      <p:sp>
        <p:nvSpPr>
          <p:cNvPr id="5" name="TextBox 4"/>
          <p:cNvSpPr txBox="1"/>
          <p:nvPr/>
        </p:nvSpPr>
        <p:spPr>
          <a:xfrm>
            <a:off x="685800" y="4495800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</a:p>
        </p:txBody>
      </p:sp>
      <p:sp>
        <p:nvSpPr>
          <p:cNvPr id="9" name="TextBox 8"/>
          <p:cNvSpPr txBox="1"/>
          <p:nvPr/>
        </p:nvSpPr>
        <p:spPr>
          <a:xfrm>
            <a:off x="457200" y="7619236"/>
            <a:ext cx="5803264" cy="110799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100" b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</a:t>
            </a:r>
            <a:r>
              <a:rPr lang="en-US" sz="1100" b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1 </a:t>
            </a:r>
            <a:r>
              <a:rPr lang="en-US" sz="1100" b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ure</a:t>
            </a:r>
            <a:r>
              <a:rPr lang="en-US" sz="11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US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ranscript profile for Carbonic anhydrases (A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, Light Harvesting Complexes </a:t>
            </a:r>
            <a:r>
              <a:rPr lang="en-US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B), Photosystem II (C), Photosystem I (D), ACCase subunits (E), </a:t>
            </a:r>
            <a:r>
              <a:rPr lang="en-US" sz="11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Ketoacyl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r>
              <a:rPr lang="en-US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CP synthase (F), Fatty acid synthase (G), Membrane lipid synthesis (H), Fatty acid desaturation and elongation (I), Lipid and TAG synthesis (J), Major Lipid Droplet Protein (K), Lipases (L), </a:t>
            </a:r>
            <a:r>
              <a:rPr lang="el-GR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β</a:t>
            </a:r>
            <a:r>
              <a:rPr lang="en-US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-Oxidation (M), </a:t>
            </a:r>
            <a:r>
              <a:rPr lang="en-US" sz="11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Glyoxylate</a:t>
            </a:r>
            <a:r>
              <a:rPr lang="en-US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cycle specific enzymes (N) and Starch metabolism (O and P). 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X-axis represents hours.</a:t>
            </a:r>
          </a:p>
          <a:p>
            <a:pPr algn="just"/>
            <a:endParaRPr lang="en-US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64887041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6443</TotalTime>
  <Words>808</Words>
  <Application>Microsoft Office PowerPoint</Application>
  <PresentationFormat>On-screen Show (4:3)</PresentationFormat>
  <Paragraphs>24</Paragraphs>
  <Slides>8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8</vt:i4>
      </vt:variant>
    </vt:vector>
  </HeadingPairs>
  <TitlesOfParts>
    <vt:vector size="12" baseType="lpstr">
      <vt:lpstr>Arial</vt:lpstr>
      <vt:lpstr>Calibri</vt:lpstr>
      <vt:lpstr>Times New Roman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hwsedero</dc:creator>
  <cp:lastModifiedBy>Soundarya Srirangan</cp:lastModifiedBy>
  <cp:revision>481</cp:revision>
  <cp:lastPrinted>2014-10-28T12:32:56Z</cp:lastPrinted>
  <dcterms:created xsi:type="dcterms:W3CDTF">2012-07-19T19:41:05Z</dcterms:created>
  <dcterms:modified xsi:type="dcterms:W3CDTF">2015-01-19T14:09:53Z</dcterms:modified>
</cp:coreProperties>
</file>